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163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05C52-1C6E-4DFF-B229-F5FFF8BC9756}" type="datetimeFigureOut">
              <a:rPr lang="fr-FR" smtClean="0"/>
              <a:t>14/1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57B74-74A5-4919-8223-1469E04E9A8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296829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05C52-1C6E-4DFF-B229-F5FFF8BC9756}" type="datetimeFigureOut">
              <a:rPr lang="fr-FR" smtClean="0"/>
              <a:t>14/1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57B74-74A5-4919-8223-1469E04E9A8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088843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05C52-1C6E-4DFF-B229-F5FFF8BC9756}" type="datetimeFigureOut">
              <a:rPr lang="fr-FR" smtClean="0"/>
              <a:t>14/1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57B74-74A5-4919-8223-1469E04E9A8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442060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05C52-1C6E-4DFF-B229-F5FFF8BC9756}" type="datetimeFigureOut">
              <a:rPr lang="fr-FR" smtClean="0"/>
              <a:t>14/1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57B74-74A5-4919-8223-1469E04E9A8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519057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05C52-1C6E-4DFF-B229-F5FFF8BC9756}" type="datetimeFigureOut">
              <a:rPr lang="fr-FR" smtClean="0"/>
              <a:t>14/1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57B74-74A5-4919-8223-1469E04E9A8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478928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05C52-1C6E-4DFF-B229-F5FFF8BC9756}" type="datetimeFigureOut">
              <a:rPr lang="fr-FR" smtClean="0"/>
              <a:t>14/11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57B74-74A5-4919-8223-1469E04E9A8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457743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05C52-1C6E-4DFF-B229-F5FFF8BC9756}" type="datetimeFigureOut">
              <a:rPr lang="fr-FR" smtClean="0"/>
              <a:t>14/11/2024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57B74-74A5-4919-8223-1469E04E9A8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016237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05C52-1C6E-4DFF-B229-F5FFF8BC9756}" type="datetimeFigureOut">
              <a:rPr lang="fr-FR" smtClean="0"/>
              <a:t>14/11/2024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57B74-74A5-4919-8223-1469E04E9A8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916337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05C52-1C6E-4DFF-B229-F5FFF8BC9756}" type="datetimeFigureOut">
              <a:rPr lang="fr-FR" smtClean="0"/>
              <a:t>14/11/2024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57B74-74A5-4919-8223-1469E04E9A8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316753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05C52-1C6E-4DFF-B229-F5FFF8BC9756}" type="datetimeFigureOut">
              <a:rPr lang="fr-FR" smtClean="0"/>
              <a:t>14/11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57B74-74A5-4919-8223-1469E04E9A8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294927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05C52-1C6E-4DFF-B229-F5FFF8BC9756}" type="datetimeFigureOut">
              <a:rPr lang="fr-FR" smtClean="0"/>
              <a:t>14/11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57B74-74A5-4919-8223-1469E04E9A8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194011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405C52-1C6E-4DFF-B229-F5FFF8BC9756}" type="datetimeFigureOut">
              <a:rPr lang="fr-FR" smtClean="0"/>
              <a:t>14/1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957B74-74A5-4919-8223-1469E04E9A8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525964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>
            <a:extLst>
              <a:ext uri="{FF2B5EF4-FFF2-40B4-BE49-F238E27FC236}">
                <a16:creationId xmlns:a16="http://schemas.microsoft.com/office/drawing/2014/main" id="{4EFE34AF-DBC9-499B-A1B5-A8E50C5BEFA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766" y="1519807"/>
            <a:ext cx="9144000" cy="4998720"/>
          </a:xfrm>
          <a:prstGeom prst="rect">
            <a:avLst/>
          </a:prstGeom>
        </p:spPr>
      </p:pic>
      <p:sp>
        <p:nvSpPr>
          <p:cNvPr id="6" name="ZoneTexte 5">
            <a:extLst>
              <a:ext uri="{FF2B5EF4-FFF2-40B4-BE49-F238E27FC236}">
                <a16:creationId xmlns:a16="http://schemas.microsoft.com/office/drawing/2014/main" id="{418AB0EA-621F-4AF7-963A-3F67852718CA}"/>
              </a:ext>
            </a:extLst>
          </p:cNvPr>
          <p:cNvSpPr txBox="1"/>
          <p:nvPr/>
        </p:nvSpPr>
        <p:spPr>
          <a:xfrm>
            <a:off x="2294628" y="3119590"/>
            <a:ext cx="396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/>
              <a:t>100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A52FA228-B701-4E7A-941D-90A91819F462}"/>
              </a:ext>
            </a:extLst>
          </p:cNvPr>
          <p:cNvSpPr txBox="1"/>
          <p:nvPr/>
        </p:nvSpPr>
        <p:spPr>
          <a:xfrm>
            <a:off x="209911" y="4071371"/>
            <a:ext cx="396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/>
              <a:t>100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74D44D0F-2759-4CA0-9588-50DD3EC279AC}"/>
              </a:ext>
            </a:extLst>
          </p:cNvPr>
          <p:cNvSpPr txBox="1"/>
          <p:nvPr/>
        </p:nvSpPr>
        <p:spPr>
          <a:xfrm>
            <a:off x="1339972" y="4505568"/>
            <a:ext cx="396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/>
              <a:t>100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24E2120F-F4C8-46D5-AAE5-A1818E560359}"/>
              </a:ext>
            </a:extLst>
          </p:cNvPr>
          <p:cNvSpPr txBox="1"/>
          <p:nvPr/>
        </p:nvSpPr>
        <p:spPr>
          <a:xfrm>
            <a:off x="943972" y="3688934"/>
            <a:ext cx="396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/>
              <a:t>94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28B207C1-4F49-45BF-8413-9F2EBC098FF2}"/>
              </a:ext>
            </a:extLst>
          </p:cNvPr>
          <p:cNvSpPr txBox="1"/>
          <p:nvPr/>
        </p:nvSpPr>
        <p:spPr>
          <a:xfrm>
            <a:off x="2062125" y="4751789"/>
            <a:ext cx="396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/>
              <a:t>96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A5A58F51-47B6-4A0D-9D0A-01B7F28DD522}"/>
              </a:ext>
            </a:extLst>
          </p:cNvPr>
          <p:cNvSpPr txBox="1"/>
          <p:nvPr/>
        </p:nvSpPr>
        <p:spPr>
          <a:xfrm>
            <a:off x="1503049" y="4194481"/>
            <a:ext cx="396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/>
              <a:t>*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1B5BFBEF-9BAA-42BB-A80D-3D8582EB8A30}"/>
              </a:ext>
            </a:extLst>
          </p:cNvPr>
          <p:cNvSpPr txBox="1"/>
          <p:nvPr/>
        </p:nvSpPr>
        <p:spPr>
          <a:xfrm>
            <a:off x="1108704" y="5708993"/>
            <a:ext cx="396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/>
              <a:t>*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C4863CD4-A399-40DB-96F8-360E8D18595D}"/>
              </a:ext>
            </a:extLst>
          </p:cNvPr>
          <p:cNvSpPr txBox="1"/>
          <p:nvPr/>
        </p:nvSpPr>
        <p:spPr>
          <a:xfrm>
            <a:off x="1537972" y="5832639"/>
            <a:ext cx="396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/>
              <a:t>*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6244D51D-DF15-434C-9DF0-01AFB52A7D37}"/>
              </a:ext>
            </a:extLst>
          </p:cNvPr>
          <p:cNvSpPr txBox="1"/>
          <p:nvPr/>
        </p:nvSpPr>
        <p:spPr>
          <a:xfrm>
            <a:off x="215516" y="116632"/>
            <a:ext cx="6660740" cy="6463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just"/>
            <a:r>
              <a:rPr lang="fr-FR" sz="1200" b="1"/>
              <a:t>Appendix S2</a:t>
            </a:r>
            <a:endParaRPr lang="fr-FR" sz="1200" b="1" dirty="0"/>
          </a:p>
          <a:p>
            <a:pPr algn="just"/>
            <a:r>
              <a:rPr lang="en-US" sz="1200"/>
              <a:t>The phylogenetic tree obtained with the sequences of the integrase gene available for the strains included in the clusters CRF94 (n=55), CRF132 (n=29) and of the three strains outside (*).</a:t>
            </a:r>
          </a:p>
        </p:txBody>
      </p:sp>
    </p:spTree>
    <p:extLst>
      <p:ext uri="{BB962C8B-B14F-4D97-AF65-F5344CB8AC3E}">
        <p14:creationId xmlns:p14="http://schemas.microsoft.com/office/powerpoint/2010/main" val="97340057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8</TotalTime>
  <Words>48</Words>
  <Application>Microsoft Office PowerPoint</Application>
  <PresentationFormat>Affichage à l'écran (4:3)</PresentationFormat>
  <Paragraphs>10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WIRDEN Marc</dc:creator>
  <cp:lastModifiedBy>WIRDEN Marc</cp:lastModifiedBy>
  <cp:revision>5</cp:revision>
  <dcterms:created xsi:type="dcterms:W3CDTF">2024-10-28T12:54:28Z</dcterms:created>
  <dcterms:modified xsi:type="dcterms:W3CDTF">2024-11-14T12:37:18Z</dcterms:modified>
</cp:coreProperties>
</file>